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1188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BF55EF1-8CE1-4385-95C4-1FFA6D2B0F58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7E58FD-3036-4E90-B62B-5BDBD04F5F7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621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AFB15C8-1510-4A2F-AA72-3AAAC0970D5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840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868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6917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42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42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845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8044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4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8122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4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613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4359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37911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751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4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2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4271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565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ACB789-5154-4877-996D-059084132D9F}" type="datetimeFigureOut">
              <a:rPr lang="en-US" smtClean="0"/>
              <a:t>1/1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98A69-F2BA-4C21-94DF-A4BB3BF9AE6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62684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>
            <a:extLst>
              <a:ext uri="{FF2B5EF4-FFF2-40B4-BE49-F238E27FC236}">
                <a16:creationId xmlns="" xmlns:a16="http://schemas.microsoft.com/office/drawing/2014/main" id="{B3C1D5C7-A86B-45EB-A37C-1FE1BDA59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E39189-2BCD-804B-A971-BAAF0A48A5D3}" type="slidenum">
              <a:rPr lang="en-US" smtClean="0"/>
              <a:t>1</a:t>
            </a:fld>
            <a:endParaRPr lang="en-US"/>
          </a:p>
        </p:txBody>
      </p:sp>
      <p:graphicFrame>
        <p:nvGraphicFramePr>
          <p:cNvPr id="5" name="Table 4">
            <a:extLst>
              <a:ext uri="{FF2B5EF4-FFF2-40B4-BE49-F238E27FC236}">
                <a16:creationId xmlns="" xmlns:a16="http://schemas.microsoft.com/office/drawing/2014/main" id="{2D021B7E-14D2-4371-A488-20D9E2AA7D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5166691"/>
              </p:ext>
            </p:extLst>
          </p:nvPr>
        </p:nvGraphicFramePr>
        <p:xfrm>
          <a:off x="609600" y="781669"/>
          <a:ext cx="7927523" cy="5786694"/>
        </p:xfrm>
        <a:graphic>
          <a:graphicData uri="http://schemas.openxmlformats.org/drawingml/2006/table">
            <a:tbl>
              <a:tblPr>
                <a:tableStyleId>{D7AC3CCA-C797-4891-BE02-D94E43425B78}</a:tableStyleId>
              </a:tblPr>
              <a:tblGrid>
                <a:gridCol w="1291591">
                  <a:extLst>
                    <a:ext uri="{9D8B030D-6E8A-4147-A177-3AD203B41FA5}">
                      <a16:colId xmlns="" xmlns:a16="http://schemas.microsoft.com/office/drawing/2014/main" val="4171618255"/>
                    </a:ext>
                  </a:extLst>
                </a:gridCol>
                <a:gridCol w="2447653">
                  <a:extLst>
                    <a:ext uri="{9D8B030D-6E8A-4147-A177-3AD203B41FA5}">
                      <a16:colId xmlns="" xmlns:a16="http://schemas.microsoft.com/office/drawing/2014/main" val="3620513855"/>
                    </a:ext>
                  </a:extLst>
                </a:gridCol>
                <a:gridCol w="1306286">
                  <a:extLst>
                    <a:ext uri="{9D8B030D-6E8A-4147-A177-3AD203B41FA5}">
                      <a16:colId xmlns="" xmlns:a16="http://schemas.microsoft.com/office/drawing/2014/main" val="3861252097"/>
                    </a:ext>
                  </a:extLst>
                </a:gridCol>
                <a:gridCol w="1223010">
                  <a:extLst>
                    <a:ext uri="{9D8B030D-6E8A-4147-A177-3AD203B41FA5}">
                      <a16:colId xmlns="" xmlns:a16="http://schemas.microsoft.com/office/drawing/2014/main" val="3232281085"/>
                    </a:ext>
                  </a:extLst>
                </a:gridCol>
                <a:gridCol w="1658983">
                  <a:extLst>
                    <a:ext uri="{9D8B030D-6E8A-4147-A177-3AD203B41FA5}">
                      <a16:colId xmlns="" xmlns:a16="http://schemas.microsoft.com/office/drawing/2014/main" val="1497246432"/>
                    </a:ext>
                  </a:extLst>
                </a:gridCol>
              </a:tblGrid>
              <a:tr h="32006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 </a:t>
                      </a:r>
                      <a:endParaRPr lang="en-US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Sequence (5’-3’) </a:t>
                      </a:r>
                      <a:endParaRPr lang="en-US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nealing Temperature </a:t>
                      </a:r>
                      <a:endParaRPr lang="en-US" sz="1000" b="1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ycle Number </a:t>
                      </a:r>
                      <a:endParaRPr lang="en-US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licon Size (bp) </a:t>
                      </a:r>
                      <a:endParaRPr lang="en-US" sz="1000" b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073355702"/>
                  </a:ext>
                </a:extLst>
              </a:tr>
              <a:tr h="49856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: CCACCCATGGCAAATTCCATGGCT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: TCTAGACGGCAGGTCAGGTCCACC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.5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8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94410393"/>
                  </a:ext>
                </a:extLst>
              </a:tr>
              <a:tr h="48851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67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: CTTTGGGTGCGACTTGACG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: GTCGACCCCGCTCCTTTT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9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96296878"/>
                  </a:ext>
                </a:extLst>
              </a:tr>
              <a:tr h="663638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urvivin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BIRC5)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: TTGAATCGCGGGACCCGTTGG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: CAGAGGCCTCAATCCATGGCA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form 1: 477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form 2: 359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soform 3: 546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185601518"/>
                  </a:ext>
                </a:extLst>
              </a:tr>
              <a:tr h="48851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β-Catenin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: ACTGGCAGCAACAGTCTTACC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: TTTGAAGGCAGTCTGTCGTAAT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1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2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815398195"/>
                  </a:ext>
                </a:extLst>
              </a:tr>
              <a:tr h="4424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mentin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: GAACGCCAGATGCGTGAAATG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: CCAGAGGGAGTGAATCCAGATTA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0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734166794"/>
                  </a:ext>
                </a:extLst>
              </a:tr>
              <a:tr h="48851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-Cadherin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: CCTTCCTCCCAATACATCTCCC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: TCTCCGCCTCCTTCTTCATC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2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028473837"/>
                  </a:ext>
                </a:extLst>
              </a:tr>
              <a:tr h="48851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-Cadherin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: CACTGCTCAGGACCCAGAT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: TAAGCCGAGTGATGGTCC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6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125842135"/>
                  </a:ext>
                </a:extLst>
              </a:tr>
              <a:tr h="48851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x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: ATGGACGGGTCCGGGGAG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: TCAGAAAACATGTCAGCTGCC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5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936367495"/>
                  </a:ext>
                </a:extLst>
              </a:tr>
              <a:tr h="48851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5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: AGCAACTCTGGATGGGATTG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: CACTGCAGAGGTGTTTCCAA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.2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9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973324515"/>
                  </a:ext>
                </a:extLst>
              </a:tr>
              <a:tr h="4424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6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: GGCCAATAAGATGGGTCTGA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: CACTGCAGAGGTGTTTCCAA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.4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5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415091902"/>
                  </a:ext>
                </a:extLst>
              </a:tr>
              <a:tr h="48851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7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: ACCCAGAAGAAGCTGAACGA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: AGACAGAGGGCAGGATAGCA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 </a:t>
                      </a:r>
                      <a:endParaRPr lang="en-US" sz="100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5 </a:t>
                      </a:r>
                      <a:endParaRPr lang="en-US" sz="1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21789" marR="21789" marT="0" marB="0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167338303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="" xmlns:a16="http://schemas.microsoft.com/office/drawing/2014/main" id="{A90DF799-65A4-4748-8AE4-6074A0F3938F}"/>
              </a:ext>
            </a:extLst>
          </p:cNvPr>
          <p:cNvSpPr txBox="1"/>
          <p:nvPr/>
        </p:nvSpPr>
        <p:spPr>
          <a:xfrm>
            <a:off x="0" y="31106"/>
            <a:ext cx="94422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Table S1. RT-PCR primer parameters: sequences, annealing temperature, cycle number, and amplicon size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5283209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61</Words>
  <Application>Microsoft Office PowerPoint</Application>
  <PresentationFormat>On-screen Show (4:3)</PresentationFormat>
  <Paragraphs>7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ri</dc:creator>
  <cp:lastModifiedBy>Sheri</cp:lastModifiedBy>
  <cp:revision>2</cp:revision>
  <dcterms:created xsi:type="dcterms:W3CDTF">2023-01-10T10:26:55Z</dcterms:created>
  <dcterms:modified xsi:type="dcterms:W3CDTF">2023-01-10T10:29:29Z</dcterms:modified>
</cp:coreProperties>
</file>